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D26AA-0E62-45A0-9094-988C879D0F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243C5-9367-4DAB-B668-EFD15C7ACA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5596A-D04D-46AF-ACBC-D6FD072A5A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0A93C-C85E-427E-A79A-52B5F1E3A9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0A50B-0F66-462F-8625-BB0D44EA63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56DF0-3C69-46C7-A028-46EFBE5A29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AEB2D-7A4E-47ED-B6E4-F28C314B5C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B844B-8FCC-4B87-A193-6BB671CA85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692B7-C76E-480B-B1AE-E01F5FBAE2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7D2F5-000D-4027-83BC-9352DB1042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4B593-B0B4-48CE-A6E7-707D406993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6FB3D-8AC2-45D4-A78D-576550557A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554071-3C45-4AC8-B0C3-A643DBFFADF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C:\Documents and Settings\Administrator\桌面\RTvsFPKM.tif"/>
          <p:cNvPicPr/>
          <p:nvPr/>
        </p:nvPicPr>
        <p:blipFill>
          <a:blip r:embed="rId1"/>
          <a:srcRect l="7028" t="5563" r="26565" b="0"/>
          <a:stretch/>
        </p:blipFill>
        <p:spPr>
          <a:xfrm>
            <a:off x="1285920" y="144360"/>
            <a:ext cx="3857760" cy="385632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857160" y="142920"/>
            <a:ext cx="1000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7"/>
          <p:cNvSpPr/>
          <p:nvPr/>
        </p:nvSpPr>
        <p:spPr>
          <a:xfrm>
            <a:off x="0" y="7786800"/>
            <a:ext cx="68580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transcription measurements by Illumina sequencing and quantitative real-time reverse transcription-PCR (qRT-PCR) assays. (A) The correlation coefficient (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between the two datasets is 0.93. (B) Comparative analysis of six candidate genes expression level by qRT-PCR and RNA-seq. qRT-PCR quantification values were compared with HHZ_ck. Error bars indicate the standard deviation.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in 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s used as an endogenous contro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组合 30"/>
          <p:cNvGrpSpPr/>
          <p:nvPr/>
        </p:nvGrpSpPr>
        <p:grpSpPr>
          <a:xfrm>
            <a:off x="-3240" y="3714480"/>
            <a:ext cx="6808320" cy="4105800"/>
            <a:chOff x="-3240" y="3714480"/>
            <a:chExt cx="6808320" cy="4105800"/>
          </a:xfrm>
        </p:grpSpPr>
        <p:grpSp>
          <p:nvGrpSpPr>
            <p:cNvPr id="45" name="组合 21"/>
            <p:cNvGrpSpPr/>
            <p:nvPr/>
          </p:nvGrpSpPr>
          <p:grpSpPr>
            <a:xfrm>
              <a:off x="280800" y="4071960"/>
              <a:ext cx="6286320" cy="3429000"/>
              <a:chOff x="280800" y="4071960"/>
              <a:chExt cx="6286320" cy="3429000"/>
            </a:xfrm>
          </p:grpSpPr>
          <p:pic>
            <p:nvPicPr>
              <p:cNvPr id="46" name="Picture 9" descr="C:\Documents and Settings\Administrator\桌面\双Y轴修改3\Os07g43570.tif"/>
              <p:cNvPicPr/>
              <p:nvPr/>
            </p:nvPicPr>
            <p:blipFill>
              <a:blip r:embed="rId2"/>
              <a:srcRect l="2707" t="7692" r="6762" b="0"/>
              <a:stretch/>
            </p:blipFill>
            <p:spPr>
              <a:xfrm>
                <a:off x="4352760" y="5901480"/>
                <a:ext cx="2214360" cy="1586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4" descr="C:\Documents and Settings\Administrator\桌面\双Y轴修改3\05g25840.tif"/>
              <p:cNvPicPr/>
              <p:nvPr/>
            </p:nvPicPr>
            <p:blipFill>
              <a:blip r:embed="rId3"/>
              <a:srcRect l="11722" t="5563" r="6250" b="0"/>
              <a:stretch/>
            </p:blipFill>
            <p:spPr>
              <a:xfrm>
                <a:off x="333000" y="5857920"/>
                <a:ext cx="2030760" cy="1643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5" descr="C:\Documents and Settings\Administrator\桌面\双Y轴修改3\Os01g72530.tif"/>
              <p:cNvPicPr/>
              <p:nvPr/>
            </p:nvPicPr>
            <p:blipFill>
              <a:blip r:embed="rId4"/>
              <a:srcRect l="8986" t="5563" r="8986" b="0"/>
              <a:stretch/>
            </p:blipFill>
            <p:spPr>
              <a:xfrm>
                <a:off x="280800" y="4105800"/>
                <a:ext cx="2012040" cy="1627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Picture 6" descr="C:\Documents and Settings\Administrator\桌面\双Y轴修改3\Os02g36880.tif"/>
              <p:cNvPicPr/>
              <p:nvPr/>
            </p:nvPicPr>
            <p:blipFill>
              <a:blip r:embed="rId5"/>
              <a:srcRect l="10935" t="5563" r="8986" b="0"/>
              <a:stretch/>
            </p:blipFill>
            <p:spPr>
              <a:xfrm>
                <a:off x="2328480" y="4095720"/>
                <a:ext cx="2000160" cy="1657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7" descr="C:\Documents and Settings\Administrator\桌面\双Y轴修改3\Os03g24930.tif"/>
              <p:cNvPicPr/>
              <p:nvPr/>
            </p:nvPicPr>
            <p:blipFill>
              <a:blip r:embed="rId6"/>
              <a:srcRect l="8986" t="5563" r="7028" b="0"/>
              <a:stretch/>
            </p:blipFill>
            <p:spPr>
              <a:xfrm>
                <a:off x="4410000" y="4071960"/>
                <a:ext cx="2121480" cy="1676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Picture 8" descr="C:\Documents and Settings\Administrator\桌面\双Y轴修改3\Os07g43560.tif"/>
              <p:cNvPicPr/>
              <p:nvPr/>
            </p:nvPicPr>
            <p:blipFill>
              <a:blip r:embed="rId7"/>
              <a:srcRect l="11722" t="5563" r="6250" b="0"/>
              <a:stretch/>
            </p:blipFill>
            <p:spPr>
              <a:xfrm>
                <a:off x="2357280" y="5857920"/>
                <a:ext cx="2030760" cy="1643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Box 13"/>
              <p:cNvSpPr/>
              <p:nvPr/>
            </p:nvSpPr>
            <p:spPr>
              <a:xfrm>
                <a:off x="852120" y="4202640"/>
                <a:ext cx="10713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1g7253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14"/>
              <p:cNvSpPr/>
              <p:nvPr/>
            </p:nvSpPr>
            <p:spPr>
              <a:xfrm>
                <a:off x="2757240" y="4190760"/>
                <a:ext cx="1250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2g368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15"/>
              <p:cNvSpPr/>
              <p:nvPr/>
            </p:nvSpPr>
            <p:spPr>
              <a:xfrm>
                <a:off x="5043240" y="4178880"/>
                <a:ext cx="13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3g2493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17"/>
              <p:cNvSpPr/>
              <p:nvPr/>
            </p:nvSpPr>
            <p:spPr>
              <a:xfrm>
                <a:off x="804600" y="5941080"/>
                <a:ext cx="1285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5g258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16"/>
              <p:cNvSpPr/>
              <p:nvPr/>
            </p:nvSpPr>
            <p:spPr>
              <a:xfrm>
                <a:off x="2781000" y="5941080"/>
                <a:ext cx="10713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7g435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18"/>
              <p:cNvSpPr/>
              <p:nvPr/>
            </p:nvSpPr>
            <p:spPr>
              <a:xfrm>
                <a:off x="4983840" y="5941080"/>
                <a:ext cx="121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s07g4357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8" name="TextBox 11"/>
            <p:cNvSpPr/>
            <p:nvPr/>
          </p:nvSpPr>
          <p:spPr>
            <a:xfrm rot="16200000">
              <a:off x="-1385280" y="5096880"/>
              <a:ext cx="3071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expression leve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2"/>
            <p:cNvSpPr/>
            <p:nvPr/>
          </p:nvSpPr>
          <p:spPr>
            <a:xfrm rot="16200000">
              <a:off x="5758560" y="5525280"/>
              <a:ext cx="1785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PKM valu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0" name="组合 24"/>
            <p:cNvGrpSpPr/>
            <p:nvPr/>
          </p:nvGrpSpPr>
          <p:grpSpPr>
            <a:xfrm>
              <a:off x="4424040" y="7572600"/>
              <a:ext cx="1923480" cy="247680"/>
              <a:chOff x="4424040" y="7572600"/>
              <a:chExt cx="1923480" cy="247680"/>
            </a:xfrm>
          </p:grpSpPr>
          <p:sp>
            <p:nvSpPr>
              <p:cNvPr id="61" name="Rectangle 12"/>
              <p:cNvSpPr/>
              <p:nvPr/>
            </p:nvSpPr>
            <p:spPr>
              <a:xfrm>
                <a:off x="4424040" y="7645320"/>
                <a:ext cx="88560" cy="75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 Box 13"/>
              <p:cNvSpPr/>
              <p:nvPr/>
            </p:nvSpPr>
            <p:spPr>
              <a:xfrm>
                <a:off x="4458960" y="7572600"/>
                <a:ext cx="129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al-time PC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14"/>
              <p:cNvSpPr/>
              <p:nvPr/>
            </p:nvSpPr>
            <p:spPr>
              <a:xfrm>
                <a:off x="5576400" y="7647120"/>
                <a:ext cx="88560" cy="759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15"/>
              <p:cNvSpPr/>
              <p:nvPr/>
            </p:nvSpPr>
            <p:spPr>
              <a:xfrm>
                <a:off x="5653080" y="7574040"/>
                <a:ext cx="69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NA-Seq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5" name="TextBox 2"/>
          <p:cNvSpPr/>
          <p:nvPr/>
        </p:nvSpPr>
        <p:spPr>
          <a:xfrm>
            <a:off x="0" y="3857760"/>
            <a:ext cx="1000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02T13:46:23Z</dcterms:created>
  <dc:creator>516</dc:creator>
  <dc:description/>
  <dc:language>en-US</dc:language>
  <cp:lastModifiedBy>Lenovo User</cp:lastModifiedBy>
  <dcterms:modified xsi:type="dcterms:W3CDTF">2014-08-30T12:34:13Z</dcterms:modified>
  <cp:revision>36</cp:revision>
  <dc:subject/>
  <dc:title>幻灯片 1</dc:title>
</cp:coreProperties>
</file>